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234" y="13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966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4104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2980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6736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821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670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1262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1066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302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784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032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5D3C57-1156-4BE2-B35D-4CCE5D8808B2}" type="datetimeFigureOut">
              <a:rPr lang="it-IT" smtClean="0"/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18ABA8-C465-4723-87BF-33A6934152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9694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8486" y="1659589"/>
            <a:ext cx="5468602" cy="3024336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4236763" y="4293096"/>
            <a:ext cx="432048" cy="3600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Rettangolo 7"/>
          <p:cNvSpPr/>
          <p:nvPr/>
        </p:nvSpPr>
        <p:spPr>
          <a:xfrm>
            <a:off x="3419872" y="4303749"/>
            <a:ext cx="432048" cy="3600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Ovale 9"/>
          <p:cNvSpPr/>
          <p:nvPr/>
        </p:nvSpPr>
        <p:spPr>
          <a:xfrm>
            <a:off x="4380779" y="4236318"/>
            <a:ext cx="288032" cy="14401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Ovale 10"/>
          <p:cNvSpPr/>
          <p:nvPr/>
        </p:nvSpPr>
        <p:spPr>
          <a:xfrm>
            <a:off x="4283968" y="4245266"/>
            <a:ext cx="288032" cy="14401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Ovale 11"/>
          <p:cNvSpPr/>
          <p:nvPr/>
        </p:nvSpPr>
        <p:spPr>
          <a:xfrm>
            <a:off x="3563888" y="4296480"/>
            <a:ext cx="288032" cy="14401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Ovale 12"/>
          <p:cNvSpPr/>
          <p:nvPr/>
        </p:nvSpPr>
        <p:spPr>
          <a:xfrm>
            <a:off x="3428256" y="4296480"/>
            <a:ext cx="288032" cy="14401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Ovale 13"/>
          <p:cNvSpPr/>
          <p:nvPr/>
        </p:nvSpPr>
        <p:spPr>
          <a:xfrm>
            <a:off x="3491880" y="4287579"/>
            <a:ext cx="288032" cy="14401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Ovale 14"/>
          <p:cNvSpPr/>
          <p:nvPr/>
        </p:nvSpPr>
        <p:spPr>
          <a:xfrm>
            <a:off x="5940152" y="4308326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Ovale 15"/>
          <p:cNvSpPr/>
          <p:nvPr/>
        </p:nvSpPr>
        <p:spPr>
          <a:xfrm>
            <a:off x="6588224" y="4360238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Ovale 16"/>
          <p:cNvSpPr/>
          <p:nvPr/>
        </p:nvSpPr>
        <p:spPr>
          <a:xfrm>
            <a:off x="6732240" y="4360238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Ovale 17"/>
          <p:cNvSpPr/>
          <p:nvPr/>
        </p:nvSpPr>
        <p:spPr>
          <a:xfrm>
            <a:off x="6117852" y="4303749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Ovale 18"/>
          <p:cNvSpPr/>
          <p:nvPr/>
        </p:nvSpPr>
        <p:spPr>
          <a:xfrm>
            <a:off x="5987304" y="4298695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Ovale 19"/>
          <p:cNvSpPr/>
          <p:nvPr/>
        </p:nvSpPr>
        <p:spPr>
          <a:xfrm>
            <a:off x="5879081" y="4300832"/>
            <a:ext cx="288032" cy="195277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CasellaDiTesto 20"/>
          <p:cNvSpPr txBox="1"/>
          <p:nvPr/>
        </p:nvSpPr>
        <p:spPr>
          <a:xfrm>
            <a:off x="323528" y="260648"/>
            <a:ext cx="635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rating scale of 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sariu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erit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 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. verticillioides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1105329" y="1677942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ing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549839" y="4380334"/>
            <a:ext cx="11521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read of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1856904" y="443711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2612926" y="443711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-3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3375422" y="443711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10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4139952" y="443711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-25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4984998" y="443711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-50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5815186" y="443076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1-75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6497166" y="4437112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6-100%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1907704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2627784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3498230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/>
          <p:cNvSpPr txBox="1"/>
          <p:nvPr/>
        </p:nvSpPr>
        <p:spPr>
          <a:xfrm>
            <a:off x="4243710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5076056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5940152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6588224" y="16288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it-IT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07735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50</Words>
  <Application>Microsoft Office PowerPoint</Application>
  <PresentationFormat>Presentazione su schermo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Università Cattolica del Sacro Cuore - Piacenz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st.maroccolab-pc</dc:creator>
  <cp:lastModifiedBy>ist.maroccolab-pc</cp:lastModifiedBy>
  <cp:revision>10</cp:revision>
  <dcterms:created xsi:type="dcterms:W3CDTF">2015-09-30T13:13:45Z</dcterms:created>
  <dcterms:modified xsi:type="dcterms:W3CDTF">2016-02-23T09:01:33Z</dcterms:modified>
</cp:coreProperties>
</file>